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8229600" cy="9601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30" autoAdjust="0"/>
    <p:restoredTop sz="94660"/>
  </p:normalViewPr>
  <p:slideViewPr>
    <p:cSldViewPr snapToGrid="0">
      <p:cViewPr varScale="1">
        <p:scale>
          <a:sx n="91" d="100"/>
          <a:sy n="91" d="100"/>
        </p:scale>
        <p:origin x="168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1571308"/>
            <a:ext cx="6995160" cy="3342640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042853"/>
            <a:ext cx="6172200" cy="2318067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792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892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511175"/>
            <a:ext cx="1774508" cy="813657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511175"/>
            <a:ext cx="5220653" cy="813657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316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558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2393635"/>
            <a:ext cx="7098030" cy="3993832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6425250"/>
            <a:ext cx="7098030" cy="2100262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899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2555875"/>
            <a:ext cx="3497580" cy="609187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2555875"/>
            <a:ext cx="3497580" cy="609187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750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511177"/>
            <a:ext cx="7098030" cy="18557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2353628"/>
            <a:ext cx="3481506" cy="1153477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3507105"/>
            <a:ext cx="3481506" cy="515842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2353628"/>
            <a:ext cx="3498652" cy="1153477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3507105"/>
            <a:ext cx="3498652" cy="515842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335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38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7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40080"/>
            <a:ext cx="2654260" cy="224028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1382397"/>
            <a:ext cx="4166235" cy="6823075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880360"/>
            <a:ext cx="2654260" cy="5336223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32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40080"/>
            <a:ext cx="2654260" cy="224028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1382397"/>
            <a:ext cx="4166235" cy="6823075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880360"/>
            <a:ext cx="2654260" cy="5336223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733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511177"/>
            <a:ext cx="709803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2555875"/>
            <a:ext cx="709803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8898892"/>
            <a:ext cx="18516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8898892"/>
            <a:ext cx="277749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8898892"/>
            <a:ext cx="18516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785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extBox 123"/>
          <p:cNvSpPr txBox="1"/>
          <p:nvPr/>
        </p:nvSpPr>
        <p:spPr>
          <a:xfrm>
            <a:off x="0" y="4576853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e)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3902210" y="4576853"/>
            <a:ext cx="406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f)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-32797" y="7237539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g)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0" y="2477939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c)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3636232" y="-45893"/>
            <a:ext cx="779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nus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3636232" y="6876323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ecies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3984810" y="7237539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h )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668231" y="7391807"/>
            <a:ext cx="20783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Streptococcus </a:t>
            </a:r>
            <a:r>
              <a:rPr lang="en-US" sz="1600" b="1" i="1" dirty="0" err="1"/>
              <a:t>luteciae</a:t>
            </a:r>
            <a:endParaRPr lang="en-US" sz="1600" b="1" i="1" dirty="0"/>
          </a:p>
        </p:txBody>
      </p:sp>
      <p:sp>
        <p:nvSpPr>
          <p:cNvPr id="138" name="TextBox 137"/>
          <p:cNvSpPr txBox="1"/>
          <p:nvPr/>
        </p:nvSpPr>
        <p:spPr>
          <a:xfrm>
            <a:off x="3905556" y="2472522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d)</a:t>
            </a:r>
          </a:p>
        </p:txBody>
      </p:sp>
      <p:sp>
        <p:nvSpPr>
          <p:cNvPr id="140" name="TextBox 139"/>
          <p:cNvSpPr txBox="1"/>
          <p:nvPr/>
        </p:nvSpPr>
        <p:spPr>
          <a:xfrm>
            <a:off x="4838655" y="7391807"/>
            <a:ext cx="16137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Blautia</a:t>
            </a:r>
            <a:r>
              <a:rPr lang="en-US" sz="1600" b="1" i="1" dirty="0"/>
              <a:t> </a:t>
            </a:r>
            <a:r>
              <a:rPr lang="en-US" sz="1600" b="1" i="1" dirty="0" err="1"/>
              <a:t>producta</a:t>
            </a:r>
            <a:endParaRPr lang="en-US" sz="1600" b="1" i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002" y="575836"/>
            <a:ext cx="3931920" cy="19223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05246" y="631327"/>
            <a:ext cx="3931920" cy="186686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6809" y="2786522"/>
            <a:ext cx="3931920" cy="189461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05246" y="2820108"/>
            <a:ext cx="3931920" cy="186102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2284" y="5003049"/>
            <a:ext cx="3931920" cy="1870833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14204" y="5004933"/>
            <a:ext cx="3931920" cy="186894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2284" y="7695509"/>
            <a:ext cx="3931920" cy="186102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14204" y="7692385"/>
            <a:ext cx="3931920" cy="1864989"/>
          </a:xfrm>
          <a:prstGeom prst="rect">
            <a:avLst/>
          </a:prstGeom>
        </p:spPr>
      </p:pic>
      <p:sp>
        <p:nvSpPr>
          <p:cNvPr id="128" name="TextBox 127"/>
          <p:cNvSpPr txBox="1"/>
          <p:nvPr/>
        </p:nvSpPr>
        <p:spPr>
          <a:xfrm>
            <a:off x="1603682" y="566778"/>
            <a:ext cx="1207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Unclassified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2070904" y="2858007"/>
            <a:ext cx="13588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Streptococcus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800872" y="4870439"/>
            <a:ext cx="11657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Oscillospira</a:t>
            </a:r>
            <a:endParaRPr lang="en-US" sz="1600" b="1" i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5321292" y="740694"/>
            <a:ext cx="1289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Enterococcus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5147391" y="2779099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Blautia</a:t>
            </a:r>
            <a:endParaRPr lang="en-US" sz="1600" b="1" i="1" dirty="0"/>
          </a:p>
        </p:txBody>
      </p:sp>
      <p:sp>
        <p:nvSpPr>
          <p:cNvPr id="133" name="TextBox 132"/>
          <p:cNvSpPr txBox="1"/>
          <p:nvPr/>
        </p:nvSpPr>
        <p:spPr>
          <a:xfrm>
            <a:off x="6338853" y="4946185"/>
            <a:ext cx="9947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Klebsiella</a:t>
            </a:r>
            <a:endParaRPr lang="en-US" sz="1600" b="1" i="1" dirty="0"/>
          </a:p>
        </p:txBody>
      </p:sp>
      <p:sp>
        <p:nvSpPr>
          <p:cNvPr id="28" name="TextBox 27"/>
          <p:cNvSpPr txBox="1"/>
          <p:nvPr/>
        </p:nvSpPr>
        <p:spPr>
          <a:xfrm>
            <a:off x="7411909" y="928152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3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0" y="382112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3779756" y="382112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4033629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49</TotalTime>
  <Words>39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glarz, Monika - ARS</dc:creator>
  <cp:lastModifiedBy>Weglarz, Monika - ARS</cp:lastModifiedBy>
  <cp:revision>28</cp:revision>
  <dcterms:created xsi:type="dcterms:W3CDTF">2020-11-23T13:57:10Z</dcterms:created>
  <dcterms:modified xsi:type="dcterms:W3CDTF">2022-05-18T11:56:41Z</dcterms:modified>
</cp:coreProperties>
</file>